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3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121402-0A3D-4EAD-BEF9-7710819B867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70665B-933E-46C6-9603-EBC7DE5D78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3C21E-2367-4DC5-A386-281E4443D9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1B6E01-4B95-4236-AD66-AD66B72DAA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93E74B-C98B-4133-AF70-388FE559D0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0DBC2D-31C6-4DED-BE89-19F88FC555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8FECD7-9ADD-4932-84F4-D376EB2543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956B18-A619-43B7-B2AE-F6DF31665F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72BC7C-D45E-4921-8AD0-66ECA14FCB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154FD-20D2-433A-9219-1164C14A3D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E3BBB7-2AD3-4B6A-A33C-9A43DBFCBF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04D834-5F1A-4E01-996F-A89EE90B4C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1D375D-7DFE-48C0-92AA-2F367F1C94BD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1"/>
          <p:cNvSpPr/>
          <p:nvPr/>
        </p:nvSpPr>
        <p:spPr>
          <a:xfrm>
            <a:off x="784080" y="9213840"/>
            <a:ext cx="584388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. 2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DFS rate (a) and OS rate (b) of in 233 ICC Patients after surgery between N0 and Nx patients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图片 1" descr="g_name~ 112"/>
          <p:cNvPicPr/>
          <p:nvPr/>
        </p:nvPicPr>
        <p:blipFill>
          <a:blip r:embed="rId1"/>
          <a:stretch/>
        </p:blipFill>
        <p:spPr>
          <a:xfrm>
            <a:off x="911160" y="4794120"/>
            <a:ext cx="3998880" cy="32004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3" name=""/>
          <p:cNvGraphicFramePr/>
          <p:nvPr/>
        </p:nvGraphicFramePr>
        <p:xfrm>
          <a:off x="784080" y="3370320"/>
          <a:ext cx="4440240" cy="1371600"/>
        </p:xfrm>
        <a:graphic>
          <a:graphicData uri="http://schemas.openxmlformats.org/drawingml/2006/table">
            <a:tbl>
              <a:tblPr/>
              <a:tblGrid>
                <a:gridCol w="811440"/>
                <a:gridCol w="1214280"/>
                <a:gridCol w="812880"/>
                <a:gridCol w="776160"/>
                <a:gridCol w="825480"/>
              </a:tblGrid>
              <a:tr h="51804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=39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(month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1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 (45.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12.1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12.1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1804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=19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(month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1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6 (34.0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 (20.0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 (18.7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4" name=""/>
          <p:cNvGraphicFramePr/>
          <p:nvPr/>
        </p:nvGraphicFramePr>
        <p:xfrm>
          <a:off x="784080" y="8047080"/>
          <a:ext cx="4481640" cy="1272960"/>
        </p:xfrm>
        <a:graphic>
          <a:graphicData uri="http://schemas.openxmlformats.org/drawingml/2006/table">
            <a:tbl>
              <a:tblPr/>
              <a:tblGrid>
                <a:gridCol w="792360"/>
                <a:gridCol w="1184400"/>
                <a:gridCol w="914400"/>
                <a:gridCol w="809280"/>
                <a:gridCol w="781200"/>
              </a:tblGrid>
              <a:tr h="51804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=39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(month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1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 (73.5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 (39.7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 (29.8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1804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=19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(month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1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3(58.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 (31.7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 (21.0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45" name="组合 4"/>
          <p:cNvGrpSpPr/>
          <p:nvPr/>
        </p:nvGrpSpPr>
        <p:grpSpPr>
          <a:xfrm>
            <a:off x="915840" y="0"/>
            <a:ext cx="3994200" cy="3195720"/>
            <a:chOff x="915840" y="0"/>
            <a:chExt cx="3994200" cy="3195720"/>
          </a:xfrm>
        </p:grpSpPr>
        <p:pic>
          <p:nvPicPr>
            <p:cNvPr id="46" name="图片 1" descr="g_name~ 103"/>
            <p:cNvPicPr/>
            <p:nvPr/>
          </p:nvPicPr>
          <p:blipFill>
            <a:blip r:embed="rId2"/>
            <a:stretch/>
          </p:blipFill>
          <p:spPr>
            <a:xfrm>
              <a:off x="915840" y="0"/>
              <a:ext cx="3994200" cy="3195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图片 1" descr="g_name~ 112"/>
            <p:cNvPicPr/>
            <p:nvPr/>
          </p:nvPicPr>
          <p:blipFill>
            <a:blip r:embed="rId3"/>
            <a:srcRect l="54090" t="9113" r="36117" b="82182"/>
            <a:stretch/>
          </p:blipFill>
          <p:spPr>
            <a:xfrm>
              <a:off x="3074040" y="435240"/>
              <a:ext cx="391680" cy="2786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8-19T08:32:35Z</dcterms:created>
  <dc:creator>Administrator</dc:creator>
  <dc:description/>
  <dc:language>en-US</dc:language>
  <cp:lastModifiedBy>Jiu-Lin Song</cp:lastModifiedBy>
  <dcterms:modified xsi:type="dcterms:W3CDTF">2023-10-21T17:35:58Z</dcterms:modified>
  <cp:revision>4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469</vt:lpwstr>
  </property>
</Properties>
</file>